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F14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65" autoAdjust="0"/>
    <p:restoredTop sz="94608" autoAdjust="0"/>
  </p:normalViewPr>
  <p:slideViewPr>
    <p:cSldViewPr>
      <p:cViewPr>
        <p:scale>
          <a:sx n="70" d="100"/>
          <a:sy n="70" d="100"/>
        </p:scale>
        <p:origin x="-1212" y="-8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634FF9-C2AB-4E97-9A7E-19E00212F2FA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FA26E0-B82A-49EE-AE77-9A2C181AB28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641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2526A-9441-4D23-8CCA-C4D41C3B8B6B}" type="datetimeFigureOut">
              <a:rPr lang="en-US" smtClean="0"/>
              <a:pPr/>
              <a:t>4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5718C-96A2-4B58-B0DB-18DE1C7DB13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22" name="Picture 22"/>
          <p:cNvPicPr>
            <a:picLocks noChangeAspect="1" noChangeArrowheads="1"/>
          </p:cNvPicPr>
          <p:nvPr/>
        </p:nvPicPr>
        <p:blipFill>
          <a:blip r:embed="rId2" cstate="print"/>
          <a:srcRect r="19248" b="12590"/>
          <a:stretch>
            <a:fillRect/>
          </a:stretch>
        </p:blipFill>
        <p:spPr bwMode="auto">
          <a:xfrm>
            <a:off x="4154311" y="685800"/>
            <a:ext cx="4989689" cy="5943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24" name="Table 23"/>
          <p:cNvGraphicFramePr>
            <a:graphicFrameLocks noGrp="1"/>
          </p:cNvGraphicFramePr>
          <p:nvPr/>
        </p:nvGraphicFramePr>
        <p:xfrm>
          <a:off x="0" y="1143000"/>
          <a:ext cx="4038600" cy="2743202"/>
        </p:xfrm>
        <a:graphic>
          <a:graphicData uri="http://schemas.openxmlformats.org/drawingml/2006/table">
            <a:tbl>
              <a:tblPr/>
              <a:tblGrid>
                <a:gridCol w="633041"/>
                <a:gridCol w="2622598"/>
                <a:gridCol w="782961"/>
              </a:tblGrid>
              <a:tr h="49876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PDB ID</a:t>
                      </a:r>
                      <a:endParaRPr lang="en-US" sz="1200" dirty="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Species and Domain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% identity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8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3f9k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HIV-2 NTD-CCD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59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8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3hph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Maedi Visna Virus NTD-CCD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31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8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1ex4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HIV-1 CCD-CTD 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89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8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1k6y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HIV-1 NTD-CCD 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88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8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3oym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PFV N224H mutant full-length intasome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17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8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3av9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HIV-1 CCD 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86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8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1c0m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Rous Sarcoma Virus CCD-CTD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23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8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2x78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PFV CCD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18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9382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1c6v</a:t>
                      </a:r>
                      <a:endParaRPr lang="en-US" sz="120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SIV integrase CCD-CTD </a:t>
                      </a:r>
                      <a:endParaRPr lang="en-US" sz="1200" dirty="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latin typeface="Arial Narrow" pitchFamily="34" charset="0"/>
                          <a:ea typeface="Times New Roman"/>
                          <a:cs typeface="Times New Roman"/>
                        </a:rPr>
                        <a:t>60</a:t>
                      </a:r>
                      <a:endParaRPr lang="en-US" sz="1200" dirty="0">
                        <a:latin typeface="Arial Narrow" pitchFamily="34" charset="0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5" name="Rectangle 3"/>
          <p:cNvSpPr>
            <a:spLocks noChangeArrowheads="1"/>
          </p:cNvSpPr>
          <p:nvPr/>
        </p:nvSpPr>
        <p:spPr bwMode="auto">
          <a:xfrm>
            <a:off x="-41678" y="0"/>
            <a:ext cx="699993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Lucida Sans Unicode" pitchFamily="34" charset="0"/>
                <a:cs typeface="Times New Roman" pitchFamily="18" charset="0"/>
              </a:rPr>
              <a:t>S1 : Ten of the major15 structural homologues of CRF02_A/G integrase identified by </a:t>
            </a:r>
            <a:r>
              <a:rPr kumimoji="0" lang="en-US" sz="16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 Narrow" pitchFamily="34" charset="0"/>
                <a:ea typeface="Lucida Sans Unicode" pitchFamily="34" charset="0"/>
                <a:cs typeface="Times New Roman" pitchFamily="18" charset="0"/>
              </a:rPr>
              <a:t>HHpred</a:t>
            </a:r>
            <a:endParaRPr kumimoji="0" 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Narrow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Arial Narrow"/>
        <a:ea typeface=""/>
        <a:cs typeface=""/>
      </a:majorFont>
      <a:minorFont>
        <a:latin typeface="Arial Narrow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2</TotalTime>
  <Words>65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llustriousII</dc:creator>
  <cp:lastModifiedBy>Estrella Moyal2</cp:lastModifiedBy>
  <cp:revision>408</cp:revision>
  <dcterms:created xsi:type="dcterms:W3CDTF">2015-02-06T16:45:11Z</dcterms:created>
  <dcterms:modified xsi:type="dcterms:W3CDTF">2015-04-23T14:31:02Z</dcterms:modified>
</cp:coreProperties>
</file>